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  <p:sldId id="265" r:id="rId3"/>
    <p:sldId id="264" r:id="rId4"/>
    <p:sldId id="263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09" userDrawn="1">
          <p15:clr>
            <a:srgbClr val="A4A3A4"/>
          </p15:clr>
        </p15:guide>
        <p15:guide id="2" pos="3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 showGuides="1">
      <p:cViewPr>
        <p:scale>
          <a:sx n="66" d="100"/>
          <a:sy n="66" d="100"/>
        </p:scale>
        <p:origin x="2016" y="-390"/>
      </p:cViewPr>
      <p:guideLst>
        <p:guide orient="horz" pos="2009"/>
        <p:guide pos="3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2" Type="http://schemas.openxmlformats.org/officeDocument/2006/relationships/image" Target="../media/image7.wmf"/><Relationship Id="rId1" Type="http://schemas.openxmlformats.org/officeDocument/2006/relationships/image" Target="../media/image6.wmf"/><Relationship Id="rId5" Type="http://schemas.openxmlformats.org/officeDocument/2006/relationships/image" Target="../media/image10.wmf"/><Relationship Id="rId4" Type="http://schemas.openxmlformats.org/officeDocument/2006/relationships/image" Target="../media/image9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wmf"/><Relationship Id="rId1" Type="http://schemas.openxmlformats.org/officeDocument/2006/relationships/image" Target="../media/image1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0646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007452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4020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47704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0530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251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430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0643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5278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3971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217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1B758-6492-451D-AA73-7838BF0D1F1D}" type="datetimeFigureOut">
              <a:rPr lang="en-GB" smtClean="0"/>
              <a:t>05/12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AA5B7-ADCC-4440-8A06-5E0754807B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173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0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9.wmf"/><Relationship Id="rId4" Type="http://schemas.openxmlformats.org/officeDocument/2006/relationships/image" Target="../media/image6.wmf"/><Relationship Id="rId9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11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jpeg"/><Relationship Id="rId4" Type="http://schemas.openxmlformats.org/officeDocument/2006/relationships/image" Target="../media/image1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48" r="9223"/>
          <a:stretch/>
        </p:blipFill>
        <p:spPr>
          <a:xfrm>
            <a:off x="104503" y="2284944"/>
            <a:ext cx="6714308" cy="236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49" r="9376"/>
          <a:stretch/>
        </p:blipFill>
        <p:spPr>
          <a:xfrm>
            <a:off x="104503" y="4642314"/>
            <a:ext cx="6701246" cy="126024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86" r="9069"/>
          <a:stretch/>
        </p:blipFill>
        <p:spPr>
          <a:xfrm>
            <a:off x="65314" y="5870830"/>
            <a:ext cx="6766560" cy="2360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738811" y="3780401"/>
            <a:ext cx="9140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9.3%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768294" y="5252508"/>
            <a:ext cx="10358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-Spike 84.7%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972821" y="7411939"/>
            <a:ext cx="8370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97.5%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6999" y="709632"/>
            <a:ext cx="5629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 smtClean="0"/>
              <a:t>eGFP</a:t>
            </a:r>
            <a:endParaRPr lang="en-GB" sz="1400" dirty="0"/>
          </a:p>
        </p:txBody>
      </p:sp>
      <p:sp>
        <p:nvSpPr>
          <p:cNvPr id="15" name="TextBox 14"/>
          <p:cNvSpPr txBox="1"/>
          <p:nvPr/>
        </p:nvSpPr>
        <p:spPr>
          <a:xfrm>
            <a:off x="2757264" y="709632"/>
            <a:ext cx="7191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C-Spike</a:t>
            </a:r>
            <a:endParaRPr lang="en-GB" sz="1400" dirty="0"/>
          </a:p>
        </p:txBody>
      </p:sp>
      <p:sp>
        <p:nvSpPr>
          <p:cNvPr id="16" name="TextBox 15"/>
          <p:cNvSpPr txBox="1"/>
          <p:nvPr/>
        </p:nvSpPr>
        <p:spPr>
          <a:xfrm>
            <a:off x="5087671" y="709632"/>
            <a:ext cx="5453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 smtClean="0"/>
              <a:t>NLuc</a:t>
            </a:r>
            <a:endParaRPr lang="en-GB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108651" y="28848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08651" y="2069658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77" y="490513"/>
            <a:ext cx="2160000" cy="16200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8594" y="490513"/>
            <a:ext cx="2160000" cy="16200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8811" y="490513"/>
            <a:ext cx="2160000" cy="1620000"/>
          </a:xfrm>
          <a:prstGeom prst="rect">
            <a:avLst/>
          </a:prstGeom>
        </p:spPr>
      </p:pic>
      <p:sp>
        <p:nvSpPr>
          <p:cNvPr id="8" name="Rectangle 7"/>
          <p:cNvSpPr/>
          <p:nvPr/>
        </p:nvSpPr>
        <p:spPr>
          <a:xfrm>
            <a:off x="65314" y="8230830"/>
            <a:ext cx="6792686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Supplementary Figure 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1.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Characterisation of mRNA integrity, size and identity by capillary electrophoresis (CE) and liquid chromatography-mass spectrometry (LC-MS) sequencing. (A) 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Capillary Electrophoretograms of </a:t>
            </a:r>
            <a:r>
              <a:rPr lang="en-GB" sz="1000" dirty="0" err="1" smtClean="0">
                <a:solidFill>
                  <a:srgbClr val="222222"/>
                </a:solidFill>
                <a:latin typeface="Arial" panose="020B0604020202020204" pitchFamily="34" charset="0"/>
              </a:rPr>
              <a:t>eGFP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, C-Spike and 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NLuc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 mRNAs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. CE electrophoretograms confirm the expected sizes of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the corresponding mRNAs </a:t>
            </a:r>
            <a:r>
              <a:rPr lang="en-GB" sz="1000" dirty="0" err="1" smtClean="0">
                <a:solidFill>
                  <a:srgbClr val="222222"/>
                </a:solidFill>
                <a:latin typeface="Arial" panose="020B0604020202020204" pitchFamily="34" charset="0"/>
              </a:rPr>
              <a:t>eGFP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(~930 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nt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), COVID spike protein (C-Spike ~4300 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nt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) and 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NanoLuc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 (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NLuc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, ~870 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nt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) and integrity of the mRNA synthesised. 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(B) Sequence 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coverage maps generated via direct RNA sequencing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of 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eGFP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, C-Spike and </a:t>
            </a:r>
            <a:r>
              <a:rPr lang="en-GB" sz="1000" dirty="0" err="1">
                <a:solidFill>
                  <a:srgbClr val="222222"/>
                </a:solidFill>
                <a:latin typeface="Arial" panose="020B0604020202020204" pitchFamily="34" charset="0"/>
              </a:rPr>
              <a:t>NLuc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 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mRNAs  using LC MS [</a:t>
            </a:r>
            <a:r>
              <a:rPr lang="en-GB" sz="1000" dirty="0" err="1" smtClean="0">
                <a:solidFill>
                  <a:srgbClr val="222222"/>
                </a:solidFill>
                <a:latin typeface="Arial" panose="020B0604020202020204" pitchFamily="34" charset="0"/>
              </a:rPr>
              <a:t>Vanhinsbergh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 et al., 2022 Anal </a:t>
            </a:r>
            <a:r>
              <a:rPr lang="en-GB" sz="1000" dirty="0" err="1" smtClean="0">
                <a:solidFill>
                  <a:srgbClr val="222222"/>
                </a:solidFill>
                <a:latin typeface="Arial" panose="020B0604020202020204" pitchFamily="34" charset="0"/>
              </a:rPr>
              <a:t>Chem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]. Each of the identified </a:t>
            </a:r>
            <a:r>
              <a:rPr lang="en-GB" sz="1000" dirty="0" err="1" smtClean="0">
                <a:solidFill>
                  <a:srgbClr val="222222"/>
                </a:solidFill>
                <a:latin typeface="Arial" panose="020B0604020202020204" pitchFamily="34" charset="0"/>
              </a:rPr>
              <a:t>oligoribonucleotide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 fragments are highlighted. The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respective sequence coverages 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obtained based on unique </a:t>
            </a:r>
            <a:r>
              <a:rPr lang="en-GB" sz="1000" dirty="0" err="1" smtClean="0">
                <a:solidFill>
                  <a:srgbClr val="222222"/>
                </a:solidFill>
                <a:latin typeface="Arial" panose="020B0604020202020204" pitchFamily="34" charset="0"/>
              </a:rPr>
              <a:t>oligoribonucleotide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 identifications for each mRNA were </a:t>
            </a:r>
            <a:r>
              <a:rPr lang="en-GB" sz="1000" dirty="0">
                <a:solidFill>
                  <a:srgbClr val="222222"/>
                </a:solidFill>
                <a:latin typeface="Arial" panose="020B0604020202020204" pitchFamily="34" charset="0"/>
              </a:rPr>
              <a:t>99.3%, 84.7% and 97.5</a:t>
            </a:r>
            <a:r>
              <a:rPr lang="en-GB" sz="1000" dirty="0" smtClean="0">
                <a:solidFill>
                  <a:srgbClr val="222222"/>
                </a:solidFill>
                <a:latin typeface="Arial" panose="020B0604020202020204" pitchFamily="34" charset="0"/>
              </a:rPr>
              <a:t>% respectively.</a:t>
            </a:r>
            <a:endParaRPr lang="en-GB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1951672" y="0"/>
            <a:ext cx="2954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2452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9409853"/>
              </p:ext>
            </p:extLst>
          </p:nvPr>
        </p:nvGraphicFramePr>
        <p:xfrm>
          <a:off x="-286095" y="805070"/>
          <a:ext cx="398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6" name="Graph" r:id="rId3" imgW="9802440" imgH="7502760" progId="Origin95.Graph">
                  <p:embed/>
                </p:oleObj>
              </mc:Choice>
              <mc:Fallback>
                <p:oleObj name="Graph" r:id="rId3" imgW="9802440" imgH="75027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286095" y="805070"/>
                        <a:ext cx="398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8749164"/>
              </p:ext>
            </p:extLst>
          </p:nvPr>
        </p:nvGraphicFramePr>
        <p:xfrm>
          <a:off x="-286096" y="4627155"/>
          <a:ext cx="398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7" name="Graph" r:id="rId5" imgW="9802440" imgH="7502760" progId="Origin95.Graph">
                  <p:embed/>
                </p:oleObj>
              </mc:Choice>
              <mc:Fallback>
                <p:oleObj name="Graph" r:id="rId5" imgW="9802440" imgH="75027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286096" y="4627155"/>
                        <a:ext cx="398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66332" y="78765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0812273"/>
              </p:ext>
            </p:extLst>
          </p:nvPr>
        </p:nvGraphicFramePr>
        <p:xfrm>
          <a:off x="-286096" y="2716113"/>
          <a:ext cx="398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8" name="Graph" r:id="rId7" imgW="9802440" imgH="7502760" progId="Origin95.Graph">
                  <p:embed/>
                </p:oleObj>
              </mc:Choice>
              <mc:Fallback>
                <p:oleObj name="Graph" r:id="rId7" imgW="9802440" imgH="75027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-286096" y="2716113"/>
                        <a:ext cx="398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4794080"/>
              </p:ext>
            </p:extLst>
          </p:nvPr>
        </p:nvGraphicFramePr>
        <p:xfrm>
          <a:off x="3113088" y="805070"/>
          <a:ext cx="398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09" name="Graph" r:id="rId9" imgW="9802440" imgH="7502760" progId="Origin95.Graph">
                  <p:embed/>
                </p:oleObj>
              </mc:Choice>
              <mc:Fallback>
                <p:oleObj name="Graph" r:id="rId9" imgW="9802440" imgH="75027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113088" y="805070"/>
                        <a:ext cx="398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9012698"/>
              </p:ext>
            </p:extLst>
          </p:nvPr>
        </p:nvGraphicFramePr>
        <p:xfrm>
          <a:off x="3113088" y="2716113"/>
          <a:ext cx="398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10" name="Graph" r:id="rId11" imgW="9802440" imgH="7502760" progId="Origin95.Graph">
                  <p:embed/>
                </p:oleObj>
              </mc:Choice>
              <mc:Fallback>
                <p:oleObj name="Graph" r:id="rId11" imgW="9802440" imgH="75027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13088" y="2716113"/>
                        <a:ext cx="398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3307091" y="787652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flipH="1">
            <a:off x="388778" y="6988962"/>
            <a:ext cx="61390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ptimisation of AEX mobile phase pH for NTP separation and RNA elution. (A) Separation of a mixture of NTPs at pH 8, 10 and 12. (B) Elution of RNA at pH 8 and 10, compared with blank runs before and after RNA injection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7483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6440156"/>
              </p:ext>
            </p:extLst>
          </p:nvPr>
        </p:nvGraphicFramePr>
        <p:xfrm>
          <a:off x="-116294" y="955307"/>
          <a:ext cx="398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3" name="Graph" r:id="rId3" imgW="9802440" imgH="7502760" progId="Origin95.Graph">
                  <p:embed/>
                </p:oleObj>
              </mc:Choice>
              <mc:Fallback>
                <p:oleObj name="Graph" r:id="rId3" imgW="9802440" imgH="75027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16294" y="955307"/>
                        <a:ext cx="398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2689559"/>
              </p:ext>
            </p:extLst>
          </p:nvPr>
        </p:nvGraphicFramePr>
        <p:xfrm>
          <a:off x="3217361" y="955307"/>
          <a:ext cx="3983037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04" name="Graph" r:id="rId5" imgW="9802440" imgH="7502760" progId="Origin95.Graph">
                  <p:embed/>
                </p:oleObj>
              </mc:Choice>
              <mc:Fallback>
                <p:oleObj name="Graph" r:id="rId5" imgW="9802440" imgH="750276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17361" y="955307"/>
                        <a:ext cx="3983037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 flipH="1">
            <a:off x="388778" y="4370886"/>
            <a:ext cx="61390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Quantification of NTPs by AEX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HPLC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EX chromatograms produced by a series dilution of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 mixture of NTP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 Calibra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urves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roduced from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P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ilu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ries ru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n triplicate over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re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ays. </a:t>
            </a:r>
          </a:p>
        </p:txBody>
      </p:sp>
    </p:spTree>
    <p:extLst>
      <p:ext uri="{BB962C8B-B14F-4D97-AF65-F5344CB8AC3E}">
        <p14:creationId xmlns:p14="http://schemas.microsoft.com/office/powerpoint/2010/main" val="2154390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"/>
          <a:srcRect l="8075" r="9555"/>
          <a:stretch/>
        </p:blipFill>
        <p:spPr>
          <a:xfrm>
            <a:off x="3429000" y="3586555"/>
            <a:ext cx="3098800" cy="2880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6502" r="10114"/>
          <a:stretch/>
        </p:blipFill>
        <p:spPr>
          <a:xfrm>
            <a:off x="253999" y="3586555"/>
            <a:ext cx="3136901" cy="2880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4"/>
          <a:srcRect l="6089" r="8164"/>
          <a:stretch/>
        </p:blipFill>
        <p:spPr>
          <a:xfrm>
            <a:off x="232488" y="832612"/>
            <a:ext cx="3225801" cy="288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/>
          <a:srcRect l="8440" r="9190"/>
          <a:stretch/>
        </p:blipFill>
        <p:spPr>
          <a:xfrm>
            <a:off x="3429000" y="832612"/>
            <a:ext cx="3098800" cy="2880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 flipH="1">
            <a:off x="388778" y="6642452"/>
            <a:ext cx="613902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Quantification of mRNA by AEX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HPLC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EX chromatograms produced by a series dilution of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-Spik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RNA. (B) Calibration curve produced from th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-Spik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ilution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ries ru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n triplicate over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wo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days.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EX chromatograms produced by a series dilution of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mRNA. (B) Calibration curve produced from the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luc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dilutio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eries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un in duplicate over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wo days.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82753" y="706646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381553" y="706646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96537" y="348279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390900" y="347764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9022829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6649</TotalTime>
  <Words>340</Words>
  <Application>Microsoft Office PowerPoint</Application>
  <PresentationFormat>A4 Paper (210x297 mm)</PresentationFormat>
  <Paragraphs>19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Graph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Dickman</dc:creator>
  <cp:lastModifiedBy>Mark Dickman</cp:lastModifiedBy>
  <cp:revision>76</cp:revision>
  <dcterms:created xsi:type="dcterms:W3CDTF">2023-05-22T14:19:29Z</dcterms:created>
  <dcterms:modified xsi:type="dcterms:W3CDTF">2023-12-06T17:05:57Z</dcterms:modified>
</cp:coreProperties>
</file>